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5.xml.rels" ContentType="application/vnd.openxmlformats-package.relationships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910CC07-92FC-407D-82FF-C14624DE74E0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0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ru-RU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Номер слайда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1BC7B20-1E8A-4253-9D32-364E5217B15A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0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ru-RU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Номер слайда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72D9E2E-0A8A-4B8F-96FF-7AF0E4F01D70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0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ru-RU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Номер слайда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46E70D2-52B3-45E9-B519-C8D4823AB22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0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ru-RU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Номер слайда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81C882B-CE1B-4004-B017-610D93DF647D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1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ru-RU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Номер слайда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4259A2D-3881-4BBD-92E8-93CCF444DA1C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37A084-A759-42F2-9216-DD2DB33687F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784875-7F7B-421D-A805-486D85ED75A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12EA06-9B09-4A51-9B3A-4411E4F469D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BC1D1A-351B-4BED-8B70-E13CB8119E6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760147-A8FC-48ED-BAD6-7CEE634F90C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74CDEE-4F8C-49A8-BF05-FD9466BE0A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37F8E4-A0E2-4820-8C8E-33FC8E5985F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F80529-F78C-4E3D-A21C-45E8FA5A68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28F57D-AB7C-4E1F-A9A7-49D5F7750F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0EACDB-201F-49F3-8156-A832E186F53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66F86D-52FE-48A9-8CE4-0594497851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0EC457-1092-4A9C-897E-BFFCBE80AE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36FA858-812A-40A5-8D63-622F7C6CC15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image" Target="../media/image7.png"/><Relationship Id="rId4" Type="http://schemas.openxmlformats.org/officeDocument/2006/relationships/image" Target="../media/image8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image" Target="../media/image11.png"/><Relationship Id="rId4" Type="http://schemas.openxmlformats.org/officeDocument/2006/relationships/image" Target="../media/image12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image" Target="../media/image15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image" Target="../media/image17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10"/>
          <p:cNvSpPr/>
          <p:nvPr/>
        </p:nvSpPr>
        <p:spPr>
          <a:xfrm>
            <a:off x="259200" y="8661240"/>
            <a:ext cx="2695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artynova et al. Supplementary 3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" descr=""/>
          <p:cNvPicPr/>
          <p:nvPr/>
        </p:nvPicPr>
        <p:blipFill>
          <a:blip r:embed="rId1"/>
          <a:srcRect l="11252" t="36740" r="12500" b="35672"/>
          <a:stretch/>
        </p:blipFill>
        <p:spPr>
          <a:xfrm>
            <a:off x="330120" y="879480"/>
            <a:ext cx="5832720" cy="1440000"/>
          </a:xfrm>
          <a:prstGeom prst="rect">
            <a:avLst/>
          </a:prstGeom>
          <a:ln w="0">
            <a:noFill/>
          </a:ln>
        </p:spPr>
      </p:pic>
      <p:sp>
        <p:nvSpPr>
          <p:cNvPr id="50" name=""/>
          <p:cNvSpPr/>
          <p:nvPr/>
        </p:nvSpPr>
        <p:spPr>
          <a:xfrm>
            <a:off x="329040" y="600120"/>
            <a:ext cx="777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Arial"/>
                <a:ea typeface="Arial"/>
              </a:rPr>
              <a:t>MDM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" descr=""/>
          <p:cNvPicPr/>
          <p:nvPr/>
        </p:nvPicPr>
        <p:blipFill>
          <a:blip r:embed="rId2"/>
          <a:srcRect l="11252" t="36475" r="14272" b="37944"/>
          <a:stretch/>
        </p:blipFill>
        <p:spPr>
          <a:xfrm>
            <a:off x="355680" y="2778120"/>
            <a:ext cx="5843520" cy="1484280"/>
          </a:xfrm>
          <a:prstGeom prst="rect">
            <a:avLst/>
          </a:prstGeom>
          <a:ln w="0">
            <a:noFill/>
          </a:ln>
        </p:spPr>
      </p:pic>
      <p:sp>
        <p:nvSpPr>
          <p:cNvPr id="52" name=""/>
          <p:cNvSpPr/>
          <p:nvPr/>
        </p:nvSpPr>
        <p:spPr>
          <a:xfrm>
            <a:off x="328680" y="2517840"/>
            <a:ext cx="529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Arial"/>
                <a:ea typeface="Arial"/>
              </a:rPr>
              <a:t>p2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" descr=""/>
          <p:cNvPicPr/>
          <p:nvPr/>
        </p:nvPicPr>
        <p:blipFill>
          <a:blip r:embed="rId3"/>
          <a:srcRect l="11042" t="36607" r="14895" b="36740"/>
          <a:stretch/>
        </p:blipFill>
        <p:spPr>
          <a:xfrm>
            <a:off x="317520" y="6559560"/>
            <a:ext cx="5942160" cy="1459080"/>
          </a:xfrm>
          <a:prstGeom prst="rect">
            <a:avLst/>
          </a:prstGeom>
          <a:ln w="0">
            <a:noFill/>
          </a:ln>
        </p:spPr>
      </p:pic>
      <p:pic>
        <p:nvPicPr>
          <p:cNvPr id="54" name="" descr=""/>
          <p:cNvPicPr/>
          <p:nvPr/>
        </p:nvPicPr>
        <p:blipFill>
          <a:blip r:embed="rId4"/>
          <a:srcRect l="11252" t="36607" r="12500" b="31933"/>
          <a:stretch/>
        </p:blipFill>
        <p:spPr>
          <a:xfrm>
            <a:off x="365040" y="4494240"/>
            <a:ext cx="5954760" cy="1635120"/>
          </a:xfrm>
          <a:prstGeom prst="rect">
            <a:avLst/>
          </a:prstGeom>
          <a:ln w="0">
            <a:noFill/>
          </a:ln>
        </p:spPr>
      </p:pic>
      <p:sp>
        <p:nvSpPr>
          <p:cNvPr id="55" name=""/>
          <p:cNvSpPr/>
          <p:nvPr/>
        </p:nvSpPr>
        <p:spPr>
          <a:xfrm>
            <a:off x="315720" y="4422600"/>
            <a:ext cx="66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Arial"/>
                <a:ea typeface="Arial"/>
              </a:rPr>
              <a:t>TP6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315720" y="6416640"/>
            <a:ext cx="66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Arial"/>
                <a:ea typeface="Arial"/>
              </a:rPr>
              <a:t>TP7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3970440" y="6539040"/>
            <a:ext cx="176040" cy="425160"/>
          </a:xfrm>
          <a:prstGeom prst="ellipse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4910040" y="6539040"/>
            <a:ext cx="176400" cy="425160"/>
          </a:xfrm>
          <a:prstGeom prst="ellipse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TextBox 10"/>
          <p:cNvSpPr/>
          <p:nvPr/>
        </p:nvSpPr>
        <p:spPr>
          <a:xfrm>
            <a:off x="259920" y="8661240"/>
            <a:ext cx="2745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artynova et al. Supplementary 3b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" descr=""/>
          <p:cNvPicPr/>
          <p:nvPr/>
        </p:nvPicPr>
        <p:blipFill>
          <a:blip r:embed="rId1"/>
          <a:srcRect l="10939" t="36475" r="14272" b="36073"/>
          <a:stretch/>
        </p:blipFill>
        <p:spPr>
          <a:xfrm>
            <a:off x="412920" y="689040"/>
            <a:ext cx="5586120" cy="1598400"/>
          </a:xfrm>
          <a:prstGeom prst="rect">
            <a:avLst/>
          </a:prstGeom>
          <a:ln w="0">
            <a:noFill/>
          </a:ln>
        </p:spPr>
      </p:pic>
      <p:sp>
        <p:nvSpPr>
          <p:cNvPr id="61" name=""/>
          <p:cNvSpPr/>
          <p:nvPr/>
        </p:nvSpPr>
        <p:spPr>
          <a:xfrm>
            <a:off x="596160" y="314280"/>
            <a:ext cx="866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Arial"/>
                <a:ea typeface="Arial"/>
              </a:rPr>
              <a:t>Notch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5257800" y="668160"/>
            <a:ext cx="371520" cy="525600"/>
          </a:xfrm>
          <a:prstGeom prst="ellipse">
            <a:avLst/>
          </a:prstGeom>
          <a:noFill/>
          <a:ln w="93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3" name="" descr=""/>
          <p:cNvPicPr/>
          <p:nvPr/>
        </p:nvPicPr>
        <p:blipFill>
          <a:blip r:embed="rId2"/>
          <a:srcRect l="11042" t="36876" r="12500" b="36876"/>
          <a:stretch/>
        </p:blipFill>
        <p:spPr>
          <a:xfrm>
            <a:off x="393840" y="2736720"/>
            <a:ext cx="5773680" cy="1546200"/>
          </a:xfrm>
          <a:prstGeom prst="rect">
            <a:avLst/>
          </a:prstGeom>
          <a:ln w="0">
            <a:noFill/>
          </a:ln>
        </p:spPr>
      </p:pic>
      <p:sp>
        <p:nvSpPr>
          <p:cNvPr id="64" name=""/>
          <p:cNvSpPr/>
          <p:nvPr/>
        </p:nvSpPr>
        <p:spPr>
          <a:xfrm>
            <a:off x="633960" y="2359080"/>
            <a:ext cx="709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Arial"/>
                <a:ea typeface="Arial"/>
              </a:rPr>
              <a:t>JAG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4457880" y="2749680"/>
            <a:ext cx="257040" cy="387360"/>
          </a:xfrm>
          <a:prstGeom prst="ellipse">
            <a:avLst/>
          </a:prstGeom>
          <a:noFill/>
          <a:ln w="93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596160" y="4302000"/>
            <a:ext cx="843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Arial"/>
                <a:ea typeface="Arial"/>
              </a:rPr>
              <a:t>FGFR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" name="" descr=""/>
          <p:cNvPicPr/>
          <p:nvPr/>
        </p:nvPicPr>
        <p:blipFill>
          <a:blip r:embed="rId3"/>
          <a:srcRect l="15521" t="32301" r="15612" b="34922"/>
          <a:stretch/>
        </p:blipFill>
        <p:spPr>
          <a:xfrm>
            <a:off x="441360" y="4675320"/>
            <a:ext cx="5716440" cy="1555560"/>
          </a:xfrm>
          <a:prstGeom prst="rect">
            <a:avLst/>
          </a:prstGeom>
          <a:ln w="0">
            <a:noFill/>
          </a:ln>
        </p:spPr>
      </p:pic>
      <p:pic>
        <p:nvPicPr>
          <p:cNvPr id="68" name="" descr=""/>
          <p:cNvPicPr/>
          <p:nvPr/>
        </p:nvPicPr>
        <p:blipFill>
          <a:blip r:embed="rId4"/>
          <a:srcRect l="15925" t="33736" r="18697" b="42152"/>
          <a:stretch/>
        </p:blipFill>
        <p:spPr>
          <a:xfrm>
            <a:off x="426960" y="6732720"/>
            <a:ext cx="5834160" cy="1677960"/>
          </a:xfrm>
          <a:prstGeom prst="rect">
            <a:avLst/>
          </a:prstGeom>
          <a:ln w="0">
            <a:noFill/>
          </a:ln>
        </p:spPr>
      </p:pic>
      <p:sp>
        <p:nvSpPr>
          <p:cNvPr id="69" name=""/>
          <p:cNvSpPr/>
          <p:nvPr/>
        </p:nvSpPr>
        <p:spPr>
          <a:xfrm>
            <a:off x="595080" y="6384960"/>
            <a:ext cx="698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Arial"/>
                <a:ea typeface="Arial"/>
              </a:rPr>
              <a:t>EFR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4140360" y="6743880"/>
            <a:ext cx="257040" cy="482400"/>
          </a:xfrm>
          <a:prstGeom prst="ellipse">
            <a:avLst/>
          </a:prstGeom>
          <a:noFill/>
          <a:ln w="93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2946240" y="6750000"/>
            <a:ext cx="257400" cy="482760"/>
          </a:xfrm>
          <a:prstGeom prst="ellipse">
            <a:avLst/>
          </a:prstGeom>
          <a:noFill/>
          <a:ln w="93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extBox 10"/>
          <p:cNvSpPr/>
          <p:nvPr/>
        </p:nvSpPr>
        <p:spPr>
          <a:xfrm>
            <a:off x="259200" y="8661240"/>
            <a:ext cx="273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artynova et al. Supplementary 3c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" name="" descr=""/>
          <p:cNvPicPr/>
          <p:nvPr/>
        </p:nvPicPr>
        <p:blipFill>
          <a:blip r:embed="rId1"/>
          <a:srcRect l="10729" t="35406" r="12500" b="37543"/>
          <a:stretch/>
        </p:blipFill>
        <p:spPr>
          <a:xfrm>
            <a:off x="698400" y="6691320"/>
            <a:ext cx="5461200" cy="1427040"/>
          </a:xfrm>
          <a:prstGeom prst="rect">
            <a:avLst/>
          </a:prstGeom>
          <a:ln w="0">
            <a:noFill/>
          </a:ln>
        </p:spPr>
      </p:pic>
      <p:pic>
        <p:nvPicPr>
          <p:cNvPr id="74" name="" descr=""/>
          <p:cNvPicPr/>
          <p:nvPr/>
        </p:nvPicPr>
        <p:blipFill>
          <a:blip r:embed="rId2"/>
          <a:srcRect l="11042" t="36475" r="12500" b="39012"/>
          <a:stretch/>
        </p:blipFill>
        <p:spPr>
          <a:xfrm>
            <a:off x="698400" y="2660760"/>
            <a:ext cx="5489640" cy="1334880"/>
          </a:xfrm>
          <a:prstGeom prst="rect">
            <a:avLst/>
          </a:prstGeom>
          <a:ln w="0">
            <a:noFill/>
          </a:ln>
        </p:spPr>
      </p:pic>
      <p:pic>
        <p:nvPicPr>
          <p:cNvPr id="75" name="" descr=""/>
          <p:cNvPicPr/>
          <p:nvPr/>
        </p:nvPicPr>
        <p:blipFill>
          <a:blip r:embed="rId3"/>
          <a:srcRect l="10939" t="36475" r="12500" b="36876"/>
          <a:stretch/>
        </p:blipFill>
        <p:spPr>
          <a:xfrm>
            <a:off x="698400" y="4597560"/>
            <a:ext cx="5499360" cy="1517400"/>
          </a:xfrm>
          <a:prstGeom prst="rect">
            <a:avLst/>
          </a:prstGeom>
          <a:ln w="0">
            <a:noFill/>
          </a:ln>
        </p:spPr>
      </p:pic>
      <p:pic>
        <p:nvPicPr>
          <p:cNvPr id="76" name="" descr=""/>
          <p:cNvPicPr/>
          <p:nvPr/>
        </p:nvPicPr>
        <p:blipFill>
          <a:blip r:embed="rId4"/>
          <a:srcRect l="11042" t="36607" r="18541" b="39012"/>
          <a:stretch/>
        </p:blipFill>
        <p:spPr>
          <a:xfrm>
            <a:off x="698400" y="601560"/>
            <a:ext cx="5499360" cy="1484280"/>
          </a:xfrm>
          <a:prstGeom prst="rect">
            <a:avLst/>
          </a:prstGeom>
          <a:ln w="0">
            <a:noFill/>
          </a:ln>
        </p:spPr>
      </p:pic>
      <p:sp>
        <p:nvSpPr>
          <p:cNvPr id="77" name=""/>
          <p:cNvSpPr/>
          <p:nvPr/>
        </p:nvSpPr>
        <p:spPr>
          <a:xfrm>
            <a:off x="596160" y="326880"/>
            <a:ext cx="676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Arial"/>
                <a:ea typeface="Arial"/>
              </a:rPr>
              <a:t>Wnt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583560" y="2346480"/>
            <a:ext cx="788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Arial"/>
                <a:ea typeface="Arial"/>
              </a:rPr>
              <a:t>Wnt7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596160" y="4403880"/>
            <a:ext cx="788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Arial"/>
                <a:ea typeface="Arial"/>
              </a:rPr>
              <a:t>Wnt9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583560" y="6423120"/>
            <a:ext cx="901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Arial"/>
                <a:ea typeface="Arial"/>
              </a:rPr>
              <a:t>Wnt10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TextBox 10"/>
          <p:cNvSpPr/>
          <p:nvPr/>
        </p:nvSpPr>
        <p:spPr>
          <a:xfrm>
            <a:off x="259920" y="8661240"/>
            <a:ext cx="270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artynova et al. Supplementary 3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2" name="" descr=""/>
          <p:cNvPicPr/>
          <p:nvPr/>
        </p:nvPicPr>
        <p:blipFill>
          <a:blip r:embed="rId1"/>
          <a:srcRect l="11148" t="36391" r="27295" b="33001"/>
          <a:stretch/>
        </p:blipFill>
        <p:spPr>
          <a:xfrm>
            <a:off x="406440" y="3971880"/>
            <a:ext cx="6022800" cy="1644840"/>
          </a:xfrm>
          <a:prstGeom prst="rect">
            <a:avLst/>
          </a:prstGeom>
          <a:ln w="0">
            <a:noFill/>
          </a:ln>
        </p:spPr>
      </p:pic>
      <p:pic>
        <p:nvPicPr>
          <p:cNvPr id="83" name="" descr=""/>
          <p:cNvPicPr/>
          <p:nvPr/>
        </p:nvPicPr>
        <p:blipFill>
          <a:blip r:embed="rId2"/>
          <a:srcRect l="11252" t="36740" r="12500" b="29392"/>
          <a:stretch/>
        </p:blipFill>
        <p:spPr>
          <a:xfrm>
            <a:off x="457200" y="6186600"/>
            <a:ext cx="5977080" cy="1776240"/>
          </a:xfrm>
          <a:prstGeom prst="rect">
            <a:avLst/>
          </a:prstGeom>
          <a:ln w="0">
            <a:noFill/>
          </a:ln>
        </p:spPr>
      </p:pic>
      <p:pic>
        <p:nvPicPr>
          <p:cNvPr id="84" name="" descr=""/>
          <p:cNvPicPr/>
          <p:nvPr/>
        </p:nvPicPr>
        <p:blipFill>
          <a:blip r:embed="rId3"/>
          <a:srcRect l="11042" t="36876" r="12500" b="33937"/>
          <a:stretch/>
        </p:blipFill>
        <p:spPr>
          <a:xfrm>
            <a:off x="368280" y="1519200"/>
            <a:ext cx="6008760" cy="1789200"/>
          </a:xfrm>
          <a:prstGeom prst="rect">
            <a:avLst/>
          </a:prstGeom>
          <a:ln w="0">
            <a:noFill/>
          </a:ln>
        </p:spPr>
      </p:pic>
      <p:sp>
        <p:nvSpPr>
          <p:cNvPr id="85" name=""/>
          <p:cNvSpPr/>
          <p:nvPr/>
        </p:nvSpPr>
        <p:spPr>
          <a:xfrm>
            <a:off x="511200" y="1181160"/>
            <a:ext cx="747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Arial"/>
              </a:rPr>
              <a:t>RAR</a:t>
            </a:r>
            <a:r>
              <a:rPr b="1" lang="it-IT" sz="16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496080" y="3657600"/>
            <a:ext cx="734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Arial"/>
              </a:rPr>
              <a:t>RAR</a:t>
            </a:r>
            <a:r>
              <a:rPr b="1" lang="it-IT" sz="16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510840" y="5842080"/>
            <a:ext cx="737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Arial"/>
              </a:rPr>
              <a:t>RXR</a:t>
            </a:r>
            <a:r>
              <a:rPr b="1" lang="it-IT" sz="16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2200320" y="1521000"/>
            <a:ext cx="390600" cy="644400"/>
          </a:xfrm>
          <a:prstGeom prst="ellipse">
            <a:avLst/>
          </a:prstGeom>
          <a:noFill/>
          <a:ln w="93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3333600" y="4006800"/>
            <a:ext cx="257400" cy="387360"/>
          </a:xfrm>
          <a:prstGeom prst="ellipse">
            <a:avLst/>
          </a:prstGeom>
          <a:noFill/>
          <a:ln w="93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10"/>
          <p:cNvSpPr/>
          <p:nvPr/>
        </p:nvSpPr>
        <p:spPr>
          <a:xfrm>
            <a:off x="259200" y="8661240"/>
            <a:ext cx="273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artynova et al. Supplementary 3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1" name="" descr=""/>
          <p:cNvPicPr/>
          <p:nvPr/>
        </p:nvPicPr>
        <p:blipFill>
          <a:blip r:embed="rId1"/>
          <a:srcRect l="11148" t="36475" r="17502" b="22847"/>
          <a:stretch/>
        </p:blipFill>
        <p:spPr>
          <a:xfrm>
            <a:off x="291960" y="1822320"/>
            <a:ext cx="5943600" cy="2641680"/>
          </a:xfrm>
          <a:prstGeom prst="rect">
            <a:avLst/>
          </a:prstGeom>
          <a:ln w="0">
            <a:noFill/>
          </a:ln>
        </p:spPr>
      </p:pic>
      <p:sp>
        <p:nvSpPr>
          <p:cNvPr id="92" name=""/>
          <p:cNvSpPr/>
          <p:nvPr/>
        </p:nvSpPr>
        <p:spPr>
          <a:xfrm>
            <a:off x="2971440" y="1063800"/>
            <a:ext cx="1351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Arial"/>
                <a:ea typeface="Arial"/>
              </a:rPr>
              <a:t>KRT Cluste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3" name="" descr=""/>
          <p:cNvPicPr/>
          <p:nvPr/>
        </p:nvPicPr>
        <p:blipFill>
          <a:blip r:embed="rId2"/>
          <a:srcRect l="19167" t="36607" r="12500" b="34603"/>
          <a:stretch/>
        </p:blipFill>
        <p:spPr>
          <a:xfrm>
            <a:off x="1917720" y="5392800"/>
            <a:ext cx="4459320" cy="1465200"/>
          </a:xfrm>
          <a:prstGeom prst="rect">
            <a:avLst/>
          </a:prstGeom>
          <a:ln w="0">
            <a:noFill/>
          </a:ln>
        </p:spPr>
      </p:pic>
      <p:sp>
        <p:nvSpPr>
          <p:cNvPr id="94" name=""/>
          <p:cNvSpPr/>
          <p:nvPr/>
        </p:nvSpPr>
        <p:spPr>
          <a:xfrm flipV="1">
            <a:off x="1868400" y="4502160"/>
            <a:ext cx="3686400" cy="799920"/>
          </a:xfrm>
          <a:prstGeom prst="line">
            <a:avLst/>
          </a:prstGeom>
          <a:ln w="381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 flipH="1" flipV="1">
            <a:off x="6068880" y="4513320"/>
            <a:ext cx="160560" cy="698400"/>
          </a:xfrm>
          <a:prstGeom prst="line">
            <a:avLst/>
          </a:prstGeom>
          <a:ln w="2844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 rot="5400000">
            <a:off x="3738960" y="-854640"/>
            <a:ext cx="42840" cy="4701960"/>
          </a:xfrm>
          <a:custGeom>
            <a:avLst/>
            <a:gdLst>
              <a:gd name="textAreaLeft" fmla="*/ 12600 w 42840"/>
              <a:gd name="textAreaRight" fmla="*/ 43200 w 42840"/>
              <a:gd name="textAreaTop" fmla="*/ 195840 h 4701960"/>
              <a:gd name="textAreaBottom" fmla="*/ 4506120 h 47019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900"/>
                  <a:pt x="0" y="1800"/>
                </a:cubicBezTo>
                <a:lnTo>
                  <a:pt x="0" y="19800"/>
                </a:lnTo>
                <a:cubicBezTo>
                  <a:pt x="0" y="20700"/>
                  <a:pt x="10800" y="21600"/>
                  <a:pt x="21600" y="21600"/>
                </a:cubicBezTo>
              </a:path>
            </a:pathLst>
          </a:custGeom>
          <a:noFill/>
          <a:ln w="381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3610080" y="5416560"/>
            <a:ext cx="257040" cy="387360"/>
          </a:xfrm>
          <a:prstGeom prst="ellipse">
            <a:avLst/>
          </a:prstGeom>
          <a:noFill/>
          <a:ln w="93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5378400" y="5413320"/>
            <a:ext cx="542880" cy="387360"/>
          </a:xfrm>
          <a:prstGeom prst="ellipse">
            <a:avLst/>
          </a:prstGeom>
          <a:noFill/>
          <a:ln w="93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2-16T13:28:33Z</dcterms:created>
  <dc:creator>Roberto Matovani</dc:creator>
  <dc:description/>
  <dc:language>en-US</dc:language>
  <cp:lastModifiedBy>Roberto Matovani</cp:lastModifiedBy>
  <dcterms:modified xsi:type="dcterms:W3CDTF">2011-12-20T14:48:28Z</dcterms:modified>
  <cp:revision>5</cp:revision>
  <dc:subject/>
  <dc:title>Slide 1</dc:title>
</cp:coreProperties>
</file>